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83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597FC-CEC3-4E19-A1C8-45452EDC2463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0307F9-5E1D-456E-98CA-0505CAAB698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247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2E658E8-CE85-430B-89D0-890910BE7A3B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24811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843DD1D-0B61-CE95-2739-0B8188D210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7C7ACE0C-9773-56A7-6044-801451B3D6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FC03A77-C433-E1EE-A941-40C7C1FC9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7BCBFB4-D1A1-FB17-3C74-A9161DA1F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3ADE5C7F-EBC9-30BB-2DDB-580E2C35C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2538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6E1AA86-F4B1-1E71-BD5D-9DFC03101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3FD42422-CA18-9F33-4676-DA80A95D85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9CD44E8D-D112-C4DD-B730-4BB082694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6B50537-4758-BDA1-F098-55B269877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1F987152-B51B-8737-26D0-43098E4E3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93609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7D3D8925-3F1C-1A25-E3BC-EBC3AB4E58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04F25AF8-45C7-7021-C4B6-B5CFBDDA35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73E8CC33-004B-7D57-721D-3302AB663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C533D60-D9E8-8A5F-6BF3-9C829B148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301CE29-B1B5-7CB2-52DC-022D7FE0E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34909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28D43B52-C872-84C2-3776-38DC3FF2A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1B1BDC0-C1D9-B4D7-4CF1-70FAB4D9E3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5B09D22-790D-C3F5-EA37-D91AF285C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6177B0E-5A95-BBBE-3E4B-8302CF69F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FE9FADED-E8D9-CC43-EAEF-F81904D82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9630783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F8DE1DC-2E7F-9948-E407-E48E34628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5A52606C-8C97-5ED9-13BD-E8624AD155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C2BD56B6-6C31-E344-E22F-440A7B96E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18918B06-FD4C-02C2-DE1E-5A1ECF7E3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3E432CB-61C3-C6E3-BAE0-D1796F6A6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69029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5508CD3-3044-C51D-42B2-DFBA33D5AA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DC348730-A5C7-0242-4BBE-8CA595AD44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C09C5F83-9340-48B8-8A9F-A368DEF05A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A549072-3326-C0C7-7B72-B3083DEE5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B42B89F3-C500-1DAF-E19A-F26B909CC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7213C88D-F33D-BE02-6B3D-9B6983533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12941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904D1EF-347B-A310-1630-A2E87677E3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2E9011E5-744F-2C55-AD09-F00C48C528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2A842919-02DD-5362-2260-9E6926B638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A799D2A4-55C3-6A26-B0FF-7341C6372D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B31A263-6F18-743D-3111-F516CEBB06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337E2D76-8950-907F-80C1-1105E61FF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3FBBE5DF-B155-9DAF-3D99-5A7D5ECBD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4CA89472-2ED0-22EF-0E74-281C4DFB8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3747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F618FF0A-DB73-C020-E24D-D3BE9B0687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2323C387-AD9A-5AA9-3A61-C7A5264B9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39EEC101-070C-8697-ABF6-EE3FBB220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EEDA1358-7EB8-5D6A-9949-0EC417421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1189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B44028A4-853C-50EA-7D4B-CC3B85614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19D876EB-4D08-62BE-0CE4-67B352B7E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FFBBBD90-D2CD-C35D-1C6C-D7A1E667E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9959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A03F62A-4AA0-2840-4FB6-E3AC983B6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3247F54-E22D-A188-410E-F1C63CAACD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A2DDCA12-86C4-96A6-2BD6-1A01C4552A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7700227-E1C6-98BF-C728-383FACA37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33C3A284-1C8B-408C-8698-2BA7EF965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C7FE515F-29CA-68FC-841C-9A4E19DD5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14166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8F2CDBC4-0476-4B66-262A-D8CE74E6E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7B302C0C-4B5A-FD54-90EC-A5F5BE2260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50B7DB89-E681-944B-FE6C-F25A7D1A3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020DF18C-255B-2761-3794-067816F0A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051C50E0-A74D-56F0-0998-59997AEC5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CD46DFA-AD27-80C8-D3EE-48F17EBBA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57450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04159778-5965-142D-314E-5A39F3225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253FA6D-3389-9576-8E21-C72EB53D3B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2F3CB279-AF6A-9C9F-226B-6C328293CD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D8E76A8-C1DD-460A-805D-720B9DD119C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DA3B9AD-8945-D2D3-B0BE-3FCFD15521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D22406F0-AC70-0C1A-DEC8-5B066BDDDD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10697E-92BA-4153-B0D3-E8BC56775A4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44679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34420" y="0"/>
            <a:ext cx="2860775" cy="214594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1193" y="1"/>
            <a:ext cx="2860775" cy="2145949"/>
          </a:xfrm>
          <a:prstGeom prst="rect">
            <a:avLst/>
          </a:prstGeom>
        </p:spPr>
      </p:pic>
      <p:sp>
        <p:nvSpPr>
          <p:cNvPr id="5" name="Szövegdoboz 3"/>
          <p:cNvSpPr txBox="1"/>
          <p:nvPr/>
        </p:nvSpPr>
        <p:spPr>
          <a:xfrm>
            <a:off x="2139757" y="14135"/>
            <a:ext cx="314510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62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en-GB" sz="1662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70290" y="490808"/>
            <a:ext cx="506870" cy="390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hu-HU" sz="969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l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hu-HU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oda1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32192" y="2147350"/>
            <a:ext cx="132786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 of tetani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03791" y="1961566"/>
            <a:ext cx="2836098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   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50  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 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0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1451197" y="1062590"/>
            <a:ext cx="181235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rmalized tetanic forc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349349" y="305744"/>
            <a:ext cx="391454" cy="1862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0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8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6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4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2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12" name="Szövegdoboz 4"/>
          <p:cNvSpPr txBox="1"/>
          <p:nvPr/>
        </p:nvSpPr>
        <p:spPr>
          <a:xfrm>
            <a:off x="5616747" y="14134"/>
            <a:ext cx="304892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62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en-GB" sz="1662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716081" y="2167213"/>
            <a:ext cx="117192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equency (Hz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230059" y="1955006"/>
            <a:ext cx="2668704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20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40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0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80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868638" y="305920"/>
            <a:ext cx="391454" cy="1862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0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8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6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4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2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5123616" y="980996"/>
            <a:ext cx="131837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rmalized forc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7889028" y="1489142"/>
            <a:ext cx="506870" cy="390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hu-HU" sz="969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l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hu-HU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oda1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61194" y="2751654"/>
            <a:ext cx="2831991" cy="219456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63205" y="2751654"/>
            <a:ext cx="2831991" cy="219456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4419821" y="3261047"/>
            <a:ext cx="587020" cy="390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hu-HU" sz="969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l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hu-HU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oku1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332192" y="4899003"/>
            <a:ext cx="132786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umber of tetani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451197" y="3814242"/>
            <a:ext cx="181235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rmalized tetanic forc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349349" y="3039641"/>
            <a:ext cx="391454" cy="1862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0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8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6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4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2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26" name="Szövegdoboz 4"/>
          <p:cNvSpPr txBox="1"/>
          <p:nvPr/>
        </p:nvSpPr>
        <p:spPr>
          <a:xfrm>
            <a:off x="2139757" y="2866697"/>
            <a:ext cx="29687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62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en-GB" sz="1662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Szövegdoboz 4"/>
          <p:cNvSpPr txBox="1"/>
          <p:nvPr/>
        </p:nvSpPr>
        <p:spPr>
          <a:xfrm>
            <a:off x="5696897" y="2879113"/>
            <a:ext cx="319318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662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en-GB" sz="1662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716081" y="4899003"/>
            <a:ext cx="117192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equency (Hz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230059" y="4713219"/>
            <a:ext cx="2612105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0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60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80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10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868638" y="3039641"/>
            <a:ext cx="391454" cy="1862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.0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8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6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4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.2</a:t>
            </a:r>
          </a:p>
          <a:p>
            <a:pPr algn="r">
              <a:lnSpc>
                <a:spcPts val="2285"/>
              </a:lnSpc>
            </a:pP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5123616" y="3732649"/>
            <a:ext cx="1318374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rmalized forc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908767" y="4145182"/>
            <a:ext cx="587020" cy="3906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hu-HU" sz="969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rl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GB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</a:t>
            </a:r>
            <a:r>
              <a:rPr lang="hu-HU" sz="969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oku1</a:t>
            </a:r>
            <a:endParaRPr lang="en-GB" sz="969" b="1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603792" y="4713219"/>
            <a:ext cx="2849255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   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50 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100            </a:t>
            </a:r>
            <a:r>
              <a:rPr lang="hu-HU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</a:t>
            </a:r>
            <a:r>
              <a:rPr lang="en-GB" sz="1246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150</a:t>
            </a:r>
          </a:p>
        </p:txBody>
      </p:sp>
      <p:sp>
        <p:nvSpPr>
          <p:cNvPr id="6" name="Szövegdoboz 5">
            <a:extLst>
              <a:ext uri="{FF2B5EF4-FFF2-40B4-BE49-F238E27FC236}">
                <a16:creationId xmlns:a16="http://schemas.microsoft.com/office/drawing/2014/main" id="{711787A5-2A05-4724-489C-FEF8902D1B85}"/>
              </a:ext>
            </a:extLst>
          </p:cNvPr>
          <p:cNvSpPr txBox="1"/>
          <p:nvPr/>
        </p:nvSpPr>
        <p:spPr>
          <a:xfrm>
            <a:off x="784782" y="5368839"/>
            <a:ext cx="1030114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</a:t>
            </a:r>
            <a:r>
              <a:rPr lang="hu-HU" sz="1400" b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5</a:t>
            </a:r>
            <a:r>
              <a:rPr lang="hu-HU" sz="1400" b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400" b="1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 vivo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atigue measurements</a:t>
            </a:r>
            <a:r>
              <a:rPr lang="hu-HU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n</a:t>
            </a:r>
            <a:r>
              <a:rPr lang="hu-HU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hu-HU" sz="1400" b="1" i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GB" sz="14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 vivo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atigue of </a:t>
            </a:r>
            <a:r>
              <a:rPr lang="hu-HU" sz="1400" i="1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uscles under control conditions and in 10 µM Yoda1 (A). The protocol contained 150 consecutive tetani. All tetani were normalized to the first one. The corresponding force-frequency relationship of </a:t>
            </a:r>
            <a:r>
              <a:rPr lang="hu-HU" sz="1400" i="1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B). </a:t>
            </a:r>
            <a:r>
              <a:rPr lang="en-GB" sz="1400" i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Ex vivo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fatigue of </a:t>
            </a:r>
            <a:r>
              <a:rPr lang="hu-HU" sz="1400" i="1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uscles under control conditions and following pretreatment in 10 µM Dooku1 (C). The corresponding force-frequency relationship of </a:t>
            </a:r>
            <a:r>
              <a:rPr lang="hu-HU" sz="1400" i="1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oleus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D). The number of animals and muscles are the same as it in the previous figure. (E) </a:t>
            </a:r>
            <a:endParaRPr lang="hu-H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7169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6</Words>
  <Application>Microsoft Office PowerPoint</Application>
  <PresentationFormat>Szélesvásznú</PresentationFormat>
  <Paragraphs>50</Paragraphs>
  <Slides>1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x Dienes</dc:creator>
  <cp:lastModifiedBy>Beatrix Dienes</cp:lastModifiedBy>
  <cp:revision>4</cp:revision>
  <dcterms:created xsi:type="dcterms:W3CDTF">2026-02-01T17:35:52Z</dcterms:created>
  <dcterms:modified xsi:type="dcterms:W3CDTF">2026-06-19T13:59:50Z</dcterms:modified>
</cp:coreProperties>
</file>